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428" autoAdjust="0"/>
    <p:restoredTop sz="94660"/>
  </p:normalViewPr>
  <p:slideViewPr>
    <p:cSldViewPr snapToGrid="0">
      <p:cViewPr varScale="1">
        <p:scale>
          <a:sx n="79" d="100"/>
          <a:sy n="79" d="100"/>
        </p:scale>
        <p:origin x="3164" y="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049339-C25A-477D-8760-0898614B53F1}" type="datetimeFigureOut">
              <a:rPr lang="zh-CN" altLang="en-US" smtClean="0"/>
              <a:t>2021/8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817CF-B78A-47F8-9FFC-D6FD14D4DE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389908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049339-C25A-477D-8760-0898614B53F1}" type="datetimeFigureOut">
              <a:rPr lang="zh-CN" altLang="en-US" smtClean="0"/>
              <a:t>2021/8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817CF-B78A-47F8-9FFC-D6FD14D4DE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911745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049339-C25A-477D-8760-0898614B53F1}" type="datetimeFigureOut">
              <a:rPr lang="zh-CN" altLang="en-US" smtClean="0"/>
              <a:t>2021/8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817CF-B78A-47F8-9FFC-D6FD14D4DE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831636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049339-C25A-477D-8760-0898614B53F1}" type="datetimeFigureOut">
              <a:rPr lang="zh-CN" altLang="en-US" smtClean="0"/>
              <a:t>2021/8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817CF-B78A-47F8-9FFC-D6FD14D4DE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486283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049339-C25A-477D-8760-0898614B53F1}" type="datetimeFigureOut">
              <a:rPr lang="zh-CN" altLang="en-US" smtClean="0"/>
              <a:t>2021/8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817CF-B78A-47F8-9FFC-D6FD14D4DE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642024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049339-C25A-477D-8760-0898614B53F1}" type="datetimeFigureOut">
              <a:rPr lang="zh-CN" altLang="en-US" smtClean="0"/>
              <a:t>2021/8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817CF-B78A-47F8-9FFC-D6FD14D4DE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38636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049339-C25A-477D-8760-0898614B53F1}" type="datetimeFigureOut">
              <a:rPr lang="zh-CN" altLang="en-US" smtClean="0"/>
              <a:t>2021/8/2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817CF-B78A-47F8-9FFC-D6FD14D4DE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6307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049339-C25A-477D-8760-0898614B53F1}" type="datetimeFigureOut">
              <a:rPr lang="zh-CN" altLang="en-US" smtClean="0"/>
              <a:t>2021/8/2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817CF-B78A-47F8-9FFC-D6FD14D4DE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028619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049339-C25A-477D-8760-0898614B53F1}" type="datetimeFigureOut">
              <a:rPr lang="zh-CN" altLang="en-US" smtClean="0"/>
              <a:t>2021/8/2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817CF-B78A-47F8-9FFC-D6FD14D4DE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877407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049339-C25A-477D-8760-0898614B53F1}" type="datetimeFigureOut">
              <a:rPr lang="zh-CN" altLang="en-US" smtClean="0"/>
              <a:t>2021/8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817CF-B78A-47F8-9FFC-D6FD14D4DE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390237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049339-C25A-477D-8760-0898614B53F1}" type="datetimeFigureOut">
              <a:rPr lang="zh-CN" altLang="en-US" smtClean="0"/>
              <a:t>2021/8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817CF-B78A-47F8-9FFC-D6FD14D4DE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877022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049339-C25A-477D-8760-0898614B53F1}" type="datetimeFigureOut">
              <a:rPr lang="zh-CN" altLang="en-US" smtClean="0"/>
              <a:t>2021/8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D817CF-B78A-47F8-9FFC-D6FD14D4DE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53497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28C37809-0803-4427-95A0-05697B9AC612}"/>
              </a:ext>
            </a:extLst>
          </p:cNvPr>
          <p:cNvSpPr txBox="1"/>
          <p:nvPr/>
        </p:nvSpPr>
        <p:spPr>
          <a:xfrm>
            <a:off x="345688" y="312502"/>
            <a:ext cx="6166624" cy="144411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S6. </a:t>
            </a:r>
            <a:r>
              <a:rPr lang="en-US" altLang="zh-CN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omparison of the area of Ca</a:t>
            </a:r>
            <a:r>
              <a:rPr lang="en-US" altLang="zh-CN" sz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2+</a:t>
            </a:r>
            <a:r>
              <a:rPr lang="en-US" altLang="zh-CN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precipitation between the bitter pit pulp and the pulp close to the bitter pit spots. Three cells were randomly selected from a different region, and 10 Ca</a:t>
            </a:r>
            <a:r>
              <a:rPr lang="en-US" altLang="zh-CN" sz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2+ </a:t>
            </a:r>
            <a:r>
              <a:rPr lang="en-US" altLang="zh-CN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recipitation particles were counted in each region. Data are presented as mean ± standard error (SE) (***difference at </a:t>
            </a:r>
            <a:r>
              <a:rPr lang="en-US" altLang="zh-CN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</a:t>
            </a:r>
            <a:r>
              <a:rPr lang="en-US" altLang="zh-CN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&lt; 0.001). BP-C</a:t>
            </a:r>
            <a:r>
              <a:rPr lang="en-US" altLang="zh-CN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, </a:t>
            </a:r>
            <a:r>
              <a:rPr lang="en-US" altLang="zh-CN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he pulp close to a bitter pit spot; BP, bitter pit pulp.</a:t>
            </a:r>
            <a:endParaRPr lang="zh-CN" altLang="zh-CN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pic>
        <p:nvPicPr>
          <p:cNvPr id="9" name="图片 8" descr="徽标&#10;&#10;描述已自动生成">
            <a:extLst>
              <a:ext uri="{FF2B5EF4-FFF2-40B4-BE49-F238E27FC236}">
                <a16:creationId xmlns:a16="http://schemas.microsoft.com/office/drawing/2014/main" id="{B590DF29-E01E-4382-89F2-1419CD825F0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67384" y="2180279"/>
            <a:ext cx="4523232" cy="35570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420128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</TotalTime>
  <Words>84</Words>
  <Application>Microsoft Office PowerPoint</Application>
  <PresentationFormat>A4 纸张(210x297 毫米)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qu haiyong</dc:creator>
  <cp:lastModifiedBy>qu haiyong</cp:lastModifiedBy>
  <cp:revision>4</cp:revision>
  <dcterms:created xsi:type="dcterms:W3CDTF">2021-08-17T16:50:32Z</dcterms:created>
  <dcterms:modified xsi:type="dcterms:W3CDTF">2021-08-21T17:54:16Z</dcterms:modified>
</cp:coreProperties>
</file>